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nifesp" initials="U" lastIdx="1" clrIdx="0">
    <p:extLst>
      <p:ext uri="{19B8F6BF-5375-455C-9EA6-DF929625EA0E}">
        <p15:presenceInfo xmlns:p15="http://schemas.microsoft.com/office/powerpoint/2012/main" userId="Unifesp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5" autoAdjust="0"/>
    <p:restoredTop sz="83284" autoAdjust="0"/>
  </p:normalViewPr>
  <p:slideViewPr>
    <p:cSldViewPr snapToGrid="0">
      <p:cViewPr varScale="1">
        <p:scale>
          <a:sx n="81" d="100"/>
          <a:sy n="81" d="100"/>
        </p:scale>
        <p:origin x="12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ja Sarcevic" userId="85f9a958-31fc-47db-b764-661f298aaa11" providerId="ADAL" clId="{296BC113-2DF9-4EF9-9CD9-27352485F696}"/>
    <pc:docChg chg="modSld">
      <pc:chgData name="Marija Sarcevic" userId="85f9a958-31fc-47db-b764-661f298aaa11" providerId="ADAL" clId="{296BC113-2DF9-4EF9-9CD9-27352485F696}" dt="2026-06-10T15:03:42.536" v="3" actId="20577"/>
      <pc:docMkLst>
        <pc:docMk/>
      </pc:docMkLst>
      <pc:sldChg chg="modSp mod">
        <pc:chgData name="Marija Sarcevic" userId="85f9a958-31fc-47db-b764-661f298aaa11" providerId="ADAL" clId="{296BC113-2DF9-4EF9-9CD9-27352485F696}" dt="2026-06-10T15:03:42.536" v="3" actId="20577"/>
        <pc:sldMkLst>
          <pc:docMk/>
          <pc:sldMk cId="1779669662" sldId="257"/>
        </pc:sldMkLst>
        <pc:spChg chg="mod">
          <ac:chgData name="Marija Sarcevic" userId="85f9a958-31fc-47db-b764-661f298aaa11" providerId="ADAL" clId="{296BC113-2DF9-4EF9-9CD9-27352485F696}" dt="2026-06-10T15:03:42.536" v="3" actId="20577"/>
          <ac:spMkLst>
            <pc:docMk/>
            <pc:sldMk cId="1779669662" sldId="257"/>
            <ac:spMk id="5" creationId="{874AB578-FE7B-CFF6-48C2-D73B5FAD8CAC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83619B-0239-4FE4-B69B-54878DB1716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8451C0-5AB9-45DE-9603-A2CA472D877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12262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Google Shape;394;p3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95" name="Google Shape;395;p3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1561943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93611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99714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62980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2194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03091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46344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32534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16026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44888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66934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13291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7F18F-77A2-49B8-AFEF-34BC473BDFA1}" type="datetimeFigureOut">
              <a:rPr lang="pt-BR" smtClean="0"/>
              <a:t>10/06/202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D23E70-E36D-464F-ADD4-B96E163416F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10843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0" name="Google Shape;400;p30"/>
          <p:cNvSpPr txBox="1">
            <a:spLocks noGrp="1"/>
          </p:cNvSpPr>
          <p:nvPr>
            <p:ph type="title"/>
          </p:nvPr>
        </p:nvSpPr>
        <p:spPr>
          <a:xfrm>
            <a:off x="1055915" y="135467"/>
            <a:ext cx="10515600" cy="6121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r>
              <a:rPr lang="pt-BR" sz="2800" dirty="0"/>
              <a:t>A375 </a:t>
            </a:r>
            <a:r>
              <a:rPr lang="pt-BR" sz="2800" dirty="0" err="1"/>
              <a:t>and</a:t>
            </a:r>
            <a:r>
              <a:rPr lang="pt-BR" sz="2800" dirty="0"/>
              <a:t> SK-MEL-28 </a:t>
            </a:r>
            <a:r>
              <a:rPr lang="pt-BR" sz="2800"/>
              <a:t>adhered </a:t>
            </a:r>
            <a:endParaRPr sz="2800" dirty="0"/>
          </a:p>
        </p:txBody>
      </p:sp>
      <p:grpSp>
        <p:nvGrpSpPr>
          <p:cNvPr id="4" name="Agrupar 3">
            <a:extLst>
              <a:ext uri="{FF2B5EF4-FFF2-40B4-BE49-F238E27FC236}">
                <a16:creationId xmlns:a16="http://schemas.microsoft.com/office/drawing/2014/main" id="{AED3FE4F-739E-EBB8-92AD-30B94F903A04}"/>
              </a:ext>
            </a:extLst>
          </p:cNvPr>
          <p:cNvGrpSpPr/>
          <p:nvPr/>
        </p:nvGrpSpPr>
        <p:grpSpPr>
          <a:xfrm>
            <a:off x="798590" y="747637"/>
            <a:ext cx="11007672" cy="4609405"/>
            <a:chOff x="760260" y="1435794"/>
            <a:chExt cx="11007672" cy="4609405"/>
          </a:xfrm>
        </p:grpSpPr>
        <p:pic>
          <p:nvPicPr>
            <p:cNvPr id="10" name="Google Shape;397;p30"/>
            <p:cNvPicPr preferRelativeResize="0"/>
            <p:nvPr/>
          </p:nvPicPr>
          <p:blipFill rotWithShape="1">
            <a:blip r:embed="rId3">
              <a:alphaModFix/>
            </a:blip>
            <a:srcRect l="31361" t="29969" r="50823" b="46678"/>
            <a:stretch/>
          </p:blipFill>
          <p:spPr>
            <a:xfrm>
              <a:off x="760260" y="1435794"/>
              <a:ext cx="2592540" cy="227260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Google Shape;401;p30"/>
            <p:cNvPicPr preferRelativeResize="0"/>
            <p:nvPr/>
          </p:nvPicPr>
          <p:blipFill rotWithShape="1">
            <a:blip r:embed="rId4">
              <a:alphaModFix/>
            </a:blip>
            <a:srcRect l="33971" t="27638" r="51753" b="53475"/>
            <a:stretch/>
          </p:blipFill>
          <p:spPr>
            <a:xfrm>
              <a:off x="760260" y="3911134"/>
              <a:ext cx="2478240" cy="213406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57FFAE63-FC58-F3D4-F50F-8946970EA492}"/>
                </a:ext>
              </a:extLst>
            </p:cNvPr>
            <p:cNvGrpSpPr/>
            <p:nvPr/>
          </p:nvGrpSpPr>
          <p:grpSpPr>
            <a:xfrm>
              <a:off x="3165963" y="1447800"/>
              <a:ext cx="8601969" cy="4597399"/>
              <a:chOff x="3165963" y="1447800"/>
              <a:chExt cx="8601969" cy="4597399"/>
            </a:xfrm>
          </p:grpSpPr>
          <p:graphicFrame>
            <p:nvGraphicFramePr>
              <p:cNvPr id="2" name="Objeto 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3595066"/>
                  </p:ext>
                </p:extLst>
              </p:nvPr>
            </p:nvGraphicFramePr>
            <p:xfrm>
              <a:off x="6470374" y="1919963"/>
              <a:ext cx="5297558" cy="357687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5" imgW="5771895" imgH="3896867" progId="Prism8.Document">
                      <p:embed/>
                    </p:oleObj>
                  </mc:Choice>
                  <mc:Fallback>
                    <p:oleObj name="Prism 8" r:id="rId5" imgW="5771895" imgH="3896867" progId="Prism8.Document">
                      <p:embed/>
                      <p:pic>
                        <p:nvPicPr>
                          <p:cNvPr id="2" name="Objeto 1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6470374" y="1919963"/>
                            <a:ext cx="5297558" cy="357687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6" name="Agrupar 5"/>
              <p:cNvGrpSpPr/>
              <p:nvPr/>
            </p:nvGrpSpPr>
            <p:grpSpPr>
              <a:xfrm>
                <a:off x="3165963" y="1447800"/>
                <a:ext cx="2608447" cy="4597399"/>
                <a:chOff x="1416675" y="1892300"/>
                <a:chExt cx="2608447" cy="4597399"/>
              </a:xfrm>
            </p:grpSpPr>
            <p:pic>
              <p:nvPicPr>
                <p:cNvPr id="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7"/>
                <a:srcRect l="24594" t="17325" r="58659" b="59428"/>
                <a:stretch/>
              </p:blipFill>
              <p:spPr bwMode="auto">
                <a:xfrm>
                  <a:off x="1416676" y="1892300"/>
                  <a:ext cx="2494924" cy="216454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8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7"/>
                <a:srcRect l="24594" t="43517" r="58659" b="33563"/>
                <a:stretch/>
              </p:blipFill>
              <p:spPr bwMode="auto">
                <a:xfrm>
                  <a:off x="1416675" y="4258456"/>
                  <a:ext cx="2608447" cy="223124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</p:grpSp>
      </p:grpSp>
      <p:sp>
        <p:nvSpPr>
          <p:cNvPr id="5" name="CaixaDeTexto 4">
            <a:extLst>
              <a:ext uri="{FF2B5EF4-FFF2-40B4-BE49-F238E27FC236}">
                <a16:creationId xmlns:a16="http://schemas.microsoft.com/office/drawing/2014/main" id="{874AB578-FE7B-CFF6-48C2-D73B5FAD8CAC}"/>
              </a:ext>
            </a:extLst>
          </p:cNvPr>
          <p:cNvSpPr txBox="1"/>
          <p:nvPr/>
        </p:nvSpPr>
        <p:spPr>
          <a:xfrm>
            <a:off x="883277" y="5398404"/>
            <a:ext cx="1068823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1</a:t>
            </a:r>
            <a:r>
              <a:rPr lang="en-US" dirty="0"/>
              <a:t>. Annexin V/PI labeling was performed on A375 and SK-MEL-28 cells maintained adhered to a growth-permissive surface for 48 h in serum-free DMEM. Cells were labeled with Annexin V (Q4, indicating apoptosis), propidium iodide (PI) (Q1, indicating late apoptosis/necrosis), or both (Q2). Non-labeled cells (Q3) represent viable cells. Values are representative of three independent experiments.</a:t>
            </a:r>
            <a:r>
              <a:rPr lang="en-US" i="1" dirty="0"/>
              <a:t> 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17796696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5</TotalTime>
  <Words>80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o Office</vt:lpstr>
      <vt:lpstr>Prism 8</vt:lpstr>
      <vt:lpstr>A375 and SK-MEL-28 adhered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Unifesp</dc:creator>
  <cp:lastModifiedBy>MDPI</cp:lastModifiedBy>
  <cp:revision>47</cp:revision>
  <dcterms:created xsi:type="dcterms:W3CDTF">2026-03-13T12:11:18Z</dcterms:created>
  <dcterms:modified xsi:type="dcterms:W3CDTF">2026-06-10T15:03:44Z</dcterms:modified>
</cp:coreProperties>
</file>